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6"/>
    <p:restoredTop sz="94681"/>
  </p:normalViewPr>
  <p:slideViewPr>
    <p:cSldViewPr snapToGrid="0" snapToObjects="1">
      <p:cViewPr varScale="1">
        <p:scale>
          <a:sx n="107" d="100"/>
          <a:sy n="107" d="100"/>
        </p:scale>
        <p:origin x="1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54B951-3CED-6641-8EDC-001F0061A924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3FB38E-3623-4E4F-9A64-5B69C85645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85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9180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315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8314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7986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633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80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764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7937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38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089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0678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F7919-AFB0-9945-8B9C-3831AF76F5C6}" type="datetimeFigureOut">
              <a:rPr kumimoji="1" lang="ja-JP" altLang="en-US" smtClean="0"/>
              <a:t>2021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03C881-AD53-754E-9CC6-96F0B4ABFB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840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785F8F-E3D3-7248-A1C1-797B5A4BEF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89361" y="1468043"/>
            <a:ext cx="7925991" cy="4007642"/>
          </a:xfrm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altLang="ja-JP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nal human papillomavirus infection and its relations with abnormal anal cytology among MSM with or without HIV infection in Japan</a:t>
            </a:r>
          </a:p>
          <a:p>
            <a:endParaRPr lang="en-US" altLang="ja-JP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ja-JP" altLang="ja-JP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isuke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ojiri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2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*, Daisuke Mizushima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sao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kano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oji Watanabe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okatsu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o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2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uk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emur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asuaki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nagaw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akahiro Aoki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Junko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num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unihisa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sukad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atsuji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ruy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Yoshimi Kikuchi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iroyuki </a:t>
            </a:r>
            <a:r>
              <a:rPr lang="en-US" altLang="ja-JP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anaga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2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Shinichi Oka </a:t>
            </a:r>
            <a:r>
              <a:rPr lang="en-US" altLang="ja-JP" sz="15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 2</a:t>
            </a:r>
            <a:r>
              <a:rPr lang="en-US" altLang="ja-JP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altLang="ja-JP" sz="15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ja-JP" sz="15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 affiliations: </a:t>
            </a:r>
            <a:endParaRPr lang="ja-JP" altLang="ja-JP" sz="1575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5" indent="-342905">
              <a:buFont typeface="+mj-lt"/>
              <a:buAutoNum type="arabicPeriod"/>
            </a:pPr>
            <a:r>
              <a:rPr lang="en-US" altLang="ja-JP" sz="15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DS Clinical Center, National Center for Global Health and Medicine, Tokyo, Japan</a:t>
            </a:r>
            <a:endParaRPr lang="ja-JP" altLang="ja-JP" sz="1575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5" indent="-342905">
              <a:buFont typeface="+mj-lt"/>
              <a:buAutoNum type="arabicPeriod"/>
            </a:pPr>
            <a:r>
              <a:rPr lang="en-US" altLang="ja-JP" sz="15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Joint Research Center for Human Retrovirus Infection, Kumamoto University, Kumamoto University, Kumamoto, Japan</a:t>
            </a:r>
            <a:endParaRPr lang="ja-JP" altLang="ja-JP" sz="1575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8635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4F301BB2-EAC5-0E4F-8A62-D8FF7074646A}"/>
              </a:ext>
            </a:extLst>
          </p:cNvPr>
          <p:cNvSpPr/>
          <p:nvPr/>
        </p:nvSpPr>
        <p:spPr>
          <a:xfrm>
            <a:off x="2743200" y="6355827"/>
            <a:ext cx="5562956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Frequency by age group was compared by chi-square for trend.</a:t>
            </a:r>
            <a:r>
              <a:rPr lang="ja-JP" altLang="ja-JP" sz="1350"/>
              <a:t> </a:t>
            </a:r>
            <a:endParaRPr lang="ja-JP" altLang="en-US" sz="135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DCA2A008-15AC-6742-A5B3-01468C273AA9}"/>
              </a:ext>
            </a:extLst>
          </p:cNvPr>
          <p:cNvSpPr/>
          <p:nvPr/>
        </p:nvSpPr>
        <p:spPr>
          <a:xfrm>
            <a:off x="220327" y="352132"/>
            <a:ext cx="8703346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350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 S1. Frequencies of </a:t>
            </a:r>
            <a:r>
              <a:rPr lang="en-US" altLang="ja-JP" sz="1350" b="1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hr</a:t>
            </a:r>
            <a:r>
              <a:rPr lang="en-US" altLang="ja-JP" sz="1350" b="1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-HPV genotype identified in different age groups (HIV+/- combined)</a:t>
            </a:r>
            <a:r>
              <a:rPr lang="en-US" altLang="ja-JP" sz="135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r>
              <a:rPr lang="ja-JP" altLang="en-US" sz="135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ja-JP" altLang="ja-JP" sz="1350" dirty="0"/>
              <a:t> </a:t>
            </a:r>
            <a:endParaRPr lang="ja-JP" altLang="en-US" sz="1350" dirty="0"/>
          </a:p>
        </p:txBody>
      </p:sp>
      <p:pic>
        <p:nvPicPr>
          <p:cNvPr id="6" name="図 5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id="{283E22A0-B6B4-0E49-9AE7-E47573D069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0804" y="831273"/>
            <a:ext cx="6082392" cy="5428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6673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</TotalTime>
  <Words>149</Words>
  <Application>Microsoft Macintosh PowerPoint</Application>
  <PresentationFormat>画面に合わせる (4:3)</PresentationFormat>
  <Paragraphs>1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輔 塩尻</dc:creator>
  <cp:lastModifiedBy>大輔 塩尻</cp:lastModifiedBy>
  <cp:revision>7</cp:revision>
  <dcterms:created xsi:type="dcterms:W3CDTF">2021-02-13T14:56:02Z</dcterms:created>
  <dcterms:modified xsi:type="dcterms:W3CDTF">2021-07-23T08:03:22Z</dcterms:modified>
</cp:coreProperties>
</file>